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7474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5643" autoAdjust="0"/>
    <p:restoredTop sz="89452" autoAdjust="0"/>
  </p:normalViewPr>
  <p:slideViewPr>
    <p:cSldViewPr snapToGrid="0">
      <p:cViewPr varScale="1">
        <p:scale>
          <a:sx n="113" d="100"/>
          <a:sy n="113" d="100"/>
        </p:scale>
        <p:origin x="42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20127F-E7C3-499D-87D0-FB73F73DE973}" type="datetimeFigureOut">
              <a:rPr lang="en-US" smtClean="0"/>
              <a:t>2/18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294EE7-32C3-4A76-8BAA-0F2EFB63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8075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294EE7-32C3-4A76-8BAA-0F2EFB63D68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3954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002AA2-643D-396E-9897-37C82F313E3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A9E1D41-D2BC-58BA-9552-052D909D247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034468-C373-0A43-9265-6F8C1B00AB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16B628-2923-9B51-14BA-6DEA6BD3B4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8C64F0-1363-F03D-CBAB-818066C5CA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5557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9B78FD-C4C3-28FE-E46B-78476FD269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B73FEB-EE35-AEB8-6D45-8F130690AF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BFEA45-A444-4626-0891-E74ECF429C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128966-8990-E71C-3593-36941573C7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348F2B-BE74-F041-8A76-7A0E763370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264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1FE38DD-2BF9-5829-B68A-7CC440475F8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624E60-D797-800A-77DB-D9807ECCB9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59B996-3A4D-B2AC-3064-92F2731120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887AA3-7C6E-3C97-ABEA-45BB846476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DB0BC9-E2FF-C1B2-BB04-8C19F543B9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4278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05ACD5-8F36-3716-24A9-D54619B0CF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581EB4-D1F8-1058-FC68-0F0E722B3A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CF9399-6487-51B8-34C7-7F0E058867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6A8CC8-5E39-10EF-D6F1-09FA6C873E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596D50-0841-FC4E-3B1D-D55644A373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825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BAA356-40EF-EA35-359D-E32B9FF174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BBB6F3-408B-77CB-EF30-8DCF4AE30D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CE6F1D-8B90-16B0-E6B3-9A4ED102B2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49C4A7-C8EC-E372-4C3D-DDF6FCA663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854AE6-DBB7-9C65-F12D-9A57990CC6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8829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FDD54F-CEE3-536E-3B37-20ED3B0BCD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5AB7BF-3839-E576-CAC5-F5D9BC958C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5AF6FA-FE95-D6BD-DF62-AB12A95101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657D9D-359E-8F69-394B-86D0C87DE4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ABD2B5-1FC5-B07D-E4A0-84611E81AA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CD874A-5497-961F-41D7-7663A6B861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213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153C7E-E3F0-0B45-EA3E-1CD11DABE0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34BEB3-2FA7-66C4-EBC3-4F2C23B91E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5E56D9-4B77-3B15-F4CB-155318B382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BACC024-FEAE-CA44-D686-C063CBF412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571FAC7-4E9D-7F6A-A1DA-F14277AB64D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F5F4EF4-97A4-E80E-E4BB-B72EDC077D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670EA3A-014B-546D-BAE3-D5B34C570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211DA68-99C5-BF6E-00C0-CD343979AE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0876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8F4C40-0ED6-5CB5-8F20-705F6D2D42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DEE02FC-6A96-4DCA-16A8-5DEB619E8E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555BA05-66F1-919B-2032-324CCACF95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FF13DDD-4F58-E5EA-2462-0BE72E4AD0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80747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11181DE-CC5E-414E-6778-C5923DBB62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AB9BF87-E610-89BC-5EFA-C9351F2E14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75B81EF-13B2-041D-3E16-EC54DF7F4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529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8A4330-DF86-604D-A4BA-E3AADFC52D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DAD60F-AD60-49D8-02F3-4A99E87594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CDF7D71-6BA7-768A-0BA9-E05350857E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9F720B-1E30-2A62-9360-788E0B98D7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A0F762-8EB7-3CFE-99D8-7F8F490A9C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656EAF-17D3-D0C7-D098-6E3C11FBD6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827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C9FE45-8DAC-E665-9AD2-969DCEBDB3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2A70F62-E3A8-ED31-3A2F-361909DFF6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F2B8889-C7D0-E4BD-6246-53D00C70FD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66F377-A668-0E56-4D49-768B4C27E5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B495D8-C24E-6905-DCF2-8D98AE85F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6D1483-02C0-5771-1DCE-C7900E2506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2778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95F7B11-ACF7-F065-A8C9-497B07D0E5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04D26F-3D44-ED5E-5930-6C46B358D4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CAAC75-30B3-8555-5B11-3EBAC0BF3F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AD1939-41DC-616A-23E0-70D1E46F687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BD8A46-AAA6-9F36-1323-CBCBB22CC8F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708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C16AC0F-394D-5904-2BCF-05AD201FC703}"/>
              </a:ext>
            </a:extLst>
          </p:cNvPr>
          <p:cNvSpPr txBox="1"/>
          <p:nvPr/>
        </p:nvSpPr>
        <p:spPr>
          <a:xfrm>
            <a:off x="7407945" y="598669"/>
            <a:ext cx="4326855" cy="52629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: Immune cell composition changes in PBMCs following hypomethylating therapy in SCLC.</a:t>
            </a:r>
            <a:b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stimated proportions of major immune cell subsets in peripheral blood mononuclear cells (PBMCs) from patients with extensive-stage small-cell lung cancer at baseline (cycle 1 day 1; C1D1) and after treatment (cycle 2 day 5; C2D5), compared with healthy donor PBMCs. Cell populations shown include B cells, NK cells, CD4⁺ T cells, CD8⁺ T cells, monocytes, neutrophils, and eosinophils. Cell-type deconvolution was performed using DNA methylation-based reference signatures. Compared with healthy PBMCs, baseline samples exhibited elevated monocyte proportions, while post-treatment samples demonstrated reduced monocytes and B cells and increased eosinophils. Boxes show interquartile ranges with medians; whiskers represent 1.5× IQR; points denote outliers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8908333-DA52-0DD8-341C-DD08A3346CC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94412" y="0"/>
            <a:ext cx="54864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7474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00</TotalTime>
  <Words>146</Words>
  <Application>Microsoft Macintosh PowerPoint</Application>
  <PresentationFormat>Widescreen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basi Farid, Elnaz</dc:creator>
  <cp:lastModifiedBy>Nephew, Kenneth P</cp:lastModifiedBy>
  <cp:revision>101</cp:revision>
  <cp:lastPrinted>2025-11-20T14:34:39Z</cp:lastPrinted>
  <dcterms:created xsi:type="dcterms:W3CDTF">2025-04-15T14:41:30Z</dcterms:created>
  <dcterms:modified xsi:type="dcterms:W3CDTF">2026-02-18T21:08:52Z</dcterms:modified>
</cp:coreProperties>
</file>